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40"/>
  </p:normalViewPr>
  <p:slideViewPr>
    <p:cSldViewPr snapToGrid="0">
      <p:cViewPr varScale="1">
        <p:scale>
          <a:sx n="112" d="100"/>
          <a:sy n="112" d="100"/>
        </p:scale>
        <p:origin x="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C6313-66C1-3CB4-08F2-F85F13EBF6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E029BA-B04B-ACFC-ADD1-C77930F3FF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5DBCC6-038C-86C2-F2B7-722223DC5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C3857-193B-F266-13D3-D0EE736D0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75A1C1-AC56-6C56-69E6-7C61928A2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161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2D33EB-A2D3-2CE6-7DC8-CA6321A26A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14B67F-D08C-E831-EBD5-85F947A54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F047E2-10C4-5B39-D8D4-3E54CF8A8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DB5F1-CC0C-3B28-3BA0-3772E37DF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DCB09A-290E-113E-F62A-1A22C9802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19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DB72B30-5BE1-E136-0B68-476935F584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EB53D7-5C75-2E1B-B6D2-6E54B2D0AC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027477-5B9F-629C-48C8-5B7798DAD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2BC0FA-F922-96FE-1369-A39C57786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E5319D-9A0F-9054-CDAA-AC5C2EC79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788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087E2-6D2D-32A9-059C-4DB905AF1D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FB1887-03B3-B5A5-9B66-C7A62572E0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04ABC3-DE8D-4B2D-1F7B-A55F7F76B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7B7C1-E9C1-0E75-DB99-D2710767C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AF40B6-0AA3-D4F2-A4BD-3156187A5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607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759D9-2569-C381-99ED-1F0CA2BE4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F8DEB5-F9BC-11A0-C3DE-402B10C545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DDFF79-D8F9-3FB6-A444-39BFCFEAB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6DD609-487E-FE3D-2F0A-E0BEA5A94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E36EBD-4F26-6D35-63B0-3D40269AD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393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8E89E-E54D-1462-FBF3-C41F60D7B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D2C1CE-34AD-8102-9D74-B80DCFF5BF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082D38-79FE-A874-4340-AD330764F6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1A9153-9D98-BFDB-04C9-01E9F3931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649AEE-B8E4-926B-44FB-F93B5C9A3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821DBC-7189-81CC-4A78-C45712EE5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179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7A6A3-B9F3-84CE-E203-C549487C5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560F5D-291E-7414-664C-3634F604FA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EBBA80-0DDE-B538-15C6-1C90BCB5E3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327ED7F-D9C5-4591-D892-A54997521B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D512D5-F760-08C4-A72A-72F77AFAAE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B7F1E5-4483-B4CA-AAC9-E073A946E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0EEC52-8961-FAAA-CE9A-38D1100B8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8CCED7-9934-52FF-E739-FABA77C12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125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2C0D1-C88D-5B91-5679-488451104C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1E4897-1543-EA64-0371-D3918D9CA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3E4438-B410-B65E-9A1F-24DBB2D4B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C0C512-0D14-3697-90A6-19E798D21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560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D12651-265C-C23A-3069-9FA9D1566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9A0E5F-03FA-BA74-5317-3A2C8D4E9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1B4172-BB7A-4621-0650-EA3F212A5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990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A42EE5-EF8D-09E2-00DD-D08CF59FD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37FE8-3390-9E42-551B-AA097601AD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B6B496-71C1-AA68-D65F-068E6EEC66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520F4F-4DD6-EC46-CF5A-DDB7117BE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F361F0-D694-E6D4-5BC3-C72ABED55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722ED6-9F1C-51C5-EEBE-EFF9281A3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73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07305-A891-B8C0-37AC-2612121B50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28C767-9EED-9758-93F5-CE92256EFC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2059CD-235D-A888-A737-85A1BB2CA1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540006-6EFD-D8DE-02F5-3ED8AFFE5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465BD7-4DFA-5375-0136-C8F512FD2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BA9FB2-ED11-B370-D27E-1B6CADE75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799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F99501-16DB-A4F2-8533-CD22916240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6320E0-C4F0-F0C9-80E9-EF8D281877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A8D0D4-5544-9EFE-74B0-68B2B8C2BC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0CBD74-C551-4047-9836-F750E5FDC387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640BA-9BD2-FACB-A935-6B3CA76B5F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07ABDB-7D8D-AE98-8F41-010D2D7593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9B292-ED4E-224D-B437-1D2001EE5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01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2DAE840-E773-D9DE-3344-BEF3B215C1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483" y="689916"/>
            <a:ext cx="8364957" cy="63052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10AE808-FB8B-705E-F6CC-A32C8986CBC6}"/>
              </a:ext>
            </a:extLst>
          </p:cNvPr>
          <p:cNvSpPr txBox="1"/>
          <p:nvPr/>
        </p:nvSpPr>
        <p:spPr>
          <a:xfrm>
            <a:off x="0" y="-152400"/>
            <a:ext cx="11824335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GB" sz="1400">
                <a:solidFill>
                  <a:srgbClr val="000000"/>
                </a:solidFill>
                <a:latin typeface="+mj-lt"/>
              </a:rPr>
              <a:t>Figure S3: </a:t>
            </a:r>
            <a:r>
              <a:rPr lang="en-GB" sz="1400" dirty="0">
                <a:solidFill>
                  <a:srgbClr val="000000"/>
                </a:solidFill>
                <a:latin typeface="+mj-lt"/>
              </a:rPr>
              <a:t>Bland-Altman plot showing the </a:t>
            </a:r>
            <a:r>
              <a:rPr lang="en-GB" sz="1400" b="0" i="0" dirty="0">
                <a:solidFill>
                  <a:srgbClr val="2E2E2E"/>
                </a:solidFill>
                <a:effectLst/>
                <a:latin typeface="+mj-lt"/>
              </a:rPr>
              <a:t>the mean and difference (Session 1 – Session 2) between the </a:t>
            </a:r>
            <a:r>
              <a:rPr lang="en-GB" sz="1400" b="0" i="0" dirty="0" err="1">
                <a:solidFill>
                  <a:srgbClr val="2E2E2E"/>
                </a:solidFill>
                <a:effectLst/>
                <a:latin typeface="+mj-lt"/>
              </a:rPr>
              <a:t>ReHo</a:t>
            </a:r>
            <a:r>
              <a:rPr lang="en-GB" sz="1400" b="0" i="0" dirty="0">
                <a:solidFill>
                  <a:srgbClr val="2E2E2E"/>
                </a:solidFill>
                <a:effectLst/>
                <a:latin typeface="+mj-lt"/>
              </a:rPr>
              <a:t> estimates </a:t>
            </a:r>
            <a:r>
              <a:rPr lang="en-GB" sz="1400" dirty="0">
                <a:solidFill>
                  <a:srgbClr val="2E2E2E"/>
                </a:solidFill>
                <a:latin typeface="+mj-lt"/>
              </a:rPr>
              <a:t>for a) </a:t>
            </a:r>
            <a:r>
              <a:rPr lang="en-GB" sz="1400" kern="0" dirty="0">
                <a:effectLst/>
                <a:latin typeface="+mj-lt"/>
                <a:ea typeface="Times New Roman" panose="02020603050405020304" pitchFamily="18" charset="0"/>
              </a:rPr>
              <a:t>Siemens </a:t>
            </a:r>
            <a:r>
              <a:rPr lang="en-GB" sz="1400" kern="0" dirty="0" err="1">
                <a:effectLst/>
                <a:latin typeface="+mj-lt"/>
                <a:ea typeface="Times New Roman" panose="02020603050405020304" pitchFamily="18" charset="0"/>
              </a:rPr>
              <a:t>Skyra</a:t>
            </a:r>
            <a:r>
              <a:rPr lang="en-GB" sz="1400" kern="0" dirty="0">
                <a:effectLst/>
                <a:latin typeface="+mj-lt"/>
                <a:ea typeface="Times New Roman" panose="02020603050405020304" pitchFamily="18" charset="0"/>
              </a:rPr>
              <a:t>, b) Philips Elition X, c) GE Signa and d) Siemens Vida respectively</a:t>
            </a:r>
            <a:r>
              <a:rPr lang="en-GB" sz="1400" dirty="0">
                <a:effectLst/>
                <a:latin typeface="+mj-lt"/>
              </a:rPr>
              <a:t> </a:t>
            </a:r>
            <a:r>
              <a:rPr lang="en-GB" sz="1400" b="0" i="0" dirty="0">
                <a:solidFill>
                  <a:srgbClr val="2E2E2E"/>
                </a:solidFill>
                <a:effectLst/>
                <a:latin typeface="+mj-lt"/>
              </a:rPr>
              <a:t>. In this plot each point corresponds to AAL113 </a:t>
            </a:r>
            <a:r>
              <a:rPr lang="en-GB" sz="1400" b="0" i="0" dirty="0" err="1">
                <a:solidFill>
                  <a:srgbClr val="2E2E2E"/>
                </a:solidFill>
                <a:effectLst/>
                <a:latin typeface="+mj-lt"/>
              </a:rPr>
              <a:t>ROsI</a:t>
            </a:r>
            <a:r>
              <a:rPr lang="en-GB" sz="1400" dirty="0">
                <a:solidFill>
                  <a:srgbClr val="2E2E2E"/>
                </a:solidFill>
                <a:latin typeface="+mj-lt"/>
              </a:rPr>
              <a:t>, black 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+mj-lt"/>
              </a:rPr>
              <a:t>Horizontal depicts the mean difference, and red horizontal lines depicts the limits of agreement (</a:t>
            </a:r>
            <a:r>
              <a:rPr lang="en-GB" sz="1400" b="0" i="0" dirty="0" err="1">
                <a:solidFill>
                  <a:srgbClr val="000000"/>
                </a:solidFill>
                <a:effectLst/>
                <a:latin typeface="+mj-lt"/>
              </a:rPr>
              <a:t>LoA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+mj-lt"/>
              </a:rPr>
              <a:t>) and are defined as the mean difference ± 1.96 SD of differences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386749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jiha Bano</dc:creator>
  <cp:lastModifiedBy>Wajiha Bano</cp:lastModifiedBy>
  <cp:revision>3</cp:revision>
  <dcterms:created xsi:type="dcterms:W3CDTF">2023-08-15T12:48:36Z</dcterms:created>
  <dcterms:modified xsi:type="dcterms:W3CDTF">2023-08-21T21:04:48Z</dcterms:modified>
</cp:coreProperties>
</file>